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8" r:id="rId4"/>
    <p:sldId id="259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47" d="100"/>
          <a:sy n="47" d="100"/>
        </p:scale>
        <p:origin x="2172" y="6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8DCF01-989A-4C62-924B-6AD5BA758730}" type="datetimeFigureOut">
              <a:rPr lang="en-IN" smtClean="0"/>
              <a:pPr/>
              <a:t>28-08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040F2C-F441-4A14-9457-417E7B8347DE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692696" y="251520"/>
            <a:ext cx="4374486" cy="3139317"/>
            <a:chOff x="2195736" y="1187460"/>
            <a:chExt cx="5040560" cy="3297407"/>
          </a:xfrm>
        </p:grpSpPr>
        <p:pic>
          <p:nvPicPr>
            <p:cNvPr id="2" name="Picture 1"/>
            <p:cNvPicPr/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195736" y="1412776"/>
              <a:ext cx="5040560" cy="30720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2915816" y="1187460"/>
              <a:ext cx="420787" cy="3879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5940153" y="1187460"/>
              <a:ext cx="420788" cy="3879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5229200" y="3851920"/>
            <a:ext cx="8640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Arial Black" pitchFamily="34" charset="0"/>
              </a:rPr>
              <a:t>Fig S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DBA452F-2D7C-43A4-AB6F-C4D13639195E}"/>
              </a:ext>
            </a:extLst>
          </p:cNvPr>
          <p:cNvSpPr txBox="1"/>
          <p:nvPr/>
        </p:nvSpPr>
        <p:spPr>
          <a:xfrm>
            <a:off x="467671" y="5101794"/>
            <a:ext cx="5922658" cy="35761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1. Restriction digestion and PCR analysis of STC clone. (a)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triction digestion of pUC19 (vector) and STC (recombinant clone) with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mH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Lane1.  pUC19 plasmid DNA; lane 2, pUC19 plasmid DNA digested with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mH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ne 3, plasmid DNA of clone STC and lane 4, plasmid DNA of STC digested with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mH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)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CR analysis of STC with pUC19 primers flanking multiple cloning site.  Lane 1, PCR amplified product of pUC19; and Lane 2, PCR amplified product of clone STC. Lane M indicates the DNA molecular size marker (kb). The release of an insert of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~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 kb and its specific PCR amplification are indicated.</a:t>
            </a:r>
            <a:endParaRPr lang="en-IN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60648" y="179512"/>
            <a:ext cx="6525344" cy="61863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200" dirty="0"/>
          </a:p>
          <a:p>
            <a:endParaRPr lang="en-US" sz="1200" dirty="0"/>
          </a:p>
          <a:p>
            <a:r>
              <a:rPr lang="en-US" sz="1200" dirty="0"/>
              <a:t>5’ GTAAAACGACGGCCAGTGAATTCGAGCTCGGTACCCGGGGATCCTCGCGGCATTCATCGTCAACCTTGTCTTTC</a:t>
            </a:r>
            <a:endParaRPr lang="en-IN" sz="1200" dirty="0"/>
          </a:p>
          <a:p>
            <a:r>
              <a:rPr lang="en-US" sz="1200" dirty="0"/>
              <a:t>TTCCACCGCGATACGAAACAAGGCTATTTACGAAAATTGACCGTGCCACCAACGATATTCTGCAATGGCTGAGA</a:t>
            </a:r>
            <a:endParaRPr lang="en-IN" sz="1200" dirty="0"/>
          </a:p>
          <a:p>
            <a:r>
              <a:rPr lang="en-US" sz="1200" dirty="0"/>
              <a:t>GTGACGACAAGAAACTTATCTGATGAACCAGCCCTTAAATATGAAATTACAAGAATCCAGGACGATATGCGTTG</a:t>
            </a:r>
            <a:endParaRPr lang="en-IN" sz="1200" dirty="0"/>
          </a:p>
          <a:p>
            <a:r>
              <a:rPr lang="en-US" sz="1200" dirty="0"/>
              <a:t>GATTGATCATACCTATCTTCTTTACTCAGAAGAAAGAACGTATTTCAAAGGGAGTCACTTCTCTAAGGGAAGAA</a:t>
            </a:r>
            <a:endParaRPr lang="en-IN" sz="1200" dirty="0"/>
          </a:p>
          <a:p>
            <a:r>
              <a:rPr lang="en-US" sz="1200" dirty="0"/>
              <a:t>AAATGGTGCTTTTCCGTCAATTGATTACAACGACAAAAAAATCTTTCGATGTCCTGAAAGCTTTTTATCGTCTGG</a:t>
            </a:r>
            <a:endParaRPr lang="en-IN" sz="1200" dirty="0"/>
          </a:p>
          <a:p>
            <a:r>
              <a:rPr lang="en-US" sz="1200" dirty="0"/>
              <a:t>AACATAAAATTGAACAAATTCCAGAACAGTTTCAAGATGCCGTCGTACAAGAGCTTGATAAGTTGGTCAATGCA</a:t>
            </a:r>
            <a:endParaRPr lang="en-IN" sz="1200" dirty="0"/>
          </a:p>
          <a:p>
            <a:r>
              <a:rPr lang="en-US" sz="1200" dirty="0"/>
              <a:t>CATGAGAAATTAATTCTTAGTCTTAAAGGGCGTATTAAGAATACACATAAACAATCGTTGAGACGAATTGAGGA</a:t>
            </a:r>
            <a:endParaRPr lang="en-IN" sz="1200" dirty="0"/>
          </a:p>
          <a:p>
            <a:r>
              <a:rPr lang="en-US" sz="1200" dirty="0"/>
              <a:t>ACCTGACATCCCTTTGCTCGTAGAGCGACTGATGAGTGTATATGAAAAAAGCAATAACCCTGATAAACTGGTCT</a:t>
            </a:r>
            <a:endParaRPr lang="en-IN" sz="1200" dirty="0"/>
          </a:p>
          <a:p>
            <a:r>
              <a:rPr lang="en-US" sz="1200" dirty="0"/>
              <a:t>TCCTTCCCCTTGCTTCACAATTGATGGAGTACCACTATCAGTTGGAGCGACTCAAGAAGTTACTGAAAAGTTACC</a:t>
            </a:r>
            <a:endParaRPr lang="en-IN" sz="1200" dirty="0"/>
          </a:p>
          <a:p>
            <a:r>
              <a:rPr lang="en-US" sz="1200" dirty="0"/>
              <a:t>AGGCCCGCCATCAAGATGACTTTATCCAAACATCAGAAAAATAAAATCCAAAGAAGCCGAGTGTGCCTGACATA</a:t>
            </a:r>
            <a:endParaRPr lang="en-IN" sz="1200" dirty="0"/>
          </a:p>
          <a:p>
            <a:r>
              <a:rPr lang="en-US" sz="1200" dirty="0"/>
              <a:t>CTCGGCTTCTATTATCCCTTCTACTATCCTCCCTATTGTTAAGGCTTATTAATGCAAAAGCTCAAAAAGAGCTCAA</a:t>
            </a:r>
            <a:endParaRPr lang="en-IN" sz="1200" dirty="0"/>
          </a:p>
          <a:p>
            <a:r>
              <a:rPr lang="en-US" sz="1200" dirty="0"/>
              <a:t>GGTTATGAACCTTGAGCTGTTGATTACGTTCCCATATATTCTTGTTTATGATCATCCAGTTCCTGCACTTGATACA</a:t>
            </a:r>
            <a:endParaRPr lang="en-IN" sz="1200" dirty="0"/>
          </a:p>
          <a:p>
            <a:r>
              <a:rPr lang="en-US" sz="1200" dirty="0"/>
              <a:t>GTCATAATAATGGCCTTGTTTTTCATCAACTCCTGTGGGAGCCGAGTTCTACAATTTCACCATTCTCGATGTGGA</a:t>
            </a:r>
            <a:endParaRPr lang="en-IN" sz="1200" dirty="0"/>
          </a:p>
          <a:p>
            <a:r>
              <a:rPr lang="en-US" sz="1200" dirty="0"/>
              <a:t>CAATCCTGTCCGCATGGGTGATGGTAGAAAGCCGATGAGCCACAATAAACGTTGTCCGTTCTGAAGCTAAACGT</a:t>
            </a:r>
            <a:endParaRPr lang="en-IN" sz="1200" dirty="0"/>
          </a:p>
          <a:p>
            <a:r>
              <a:rPr lang="en-US" sz="1200" dirty="0"/>
              <a:t>TCAAGAGCATTTTGAATGAGGTGTTCACTTTCCAAATCAAGAGCAGAAGTCGCTTCATCTAAAACGAGTAACGG</a:t>
            </a:r>
            <a:endParaRPr lang="en-IN" sz="1200" dirty="0"/>
          </a:p>
          <a:p>
            <a:r>
              <a:rPr lang="en-US" sz="1200" dirty="0"/>
              <a:t>TGGGTTTTTCAAGAATACCCGCGCGATTGCCACCCTTTGCTTTTGACCACCCGATAACTTCACACCTCTTTCACCG</a:t>
            </a:r>
            <a:endParaRPr lang="en-IN" sz="1200" dirty="0"/>
          </a:p>
          <a:p>
            <a:r>
              <a:rPr lang="en-US" sz="1200" dirty="0"/>
              <a:t>ACCAACGTATCATAGCCGTTCGGAAGATTCATGATAAACTCATGGGCATTCGCCGCTTTCGCAGCTCAATCATTT</a:t>
            </a:r>
            <a:endParaRPr lang="en-IN" sz="1200" dirty="0"/>
          </a:p>
          <a:p>
            <a:r>
              <a:rPr lang="en-US" sz="1200" dirty="0"/>
              <a:t>GTTCATCCGTGGCATCCGGATTACCCATTCGTATATTCATTGCAATGGACTCACTAAAGAGAATATTATCTGAAG</a:t>
            </a:r>
            <a:endParaRPr lang="en-IN" sz="1200" dirty="0"/>
          </a:p>
          <a:p>
            <a:r>
              <a:rPr lang="en-US" sz="1200" dirty="0"/>
              <a:t>CACCATGCCAATGTTATCCCTCAGAGATCTTGCCTCAAAGTCTCTAATATCTGTTCCATCAATAGAGATGCGCCCT</a:t>
            </a:r>
            <a:endParaRPr lang="en-IN" sz="1200" dirty="0"/>
          </a:p>
          <a:p>
            <a:r>
              <a:rPr lang="en-US" sz="1200" dirty="0"/>
              <a:t>GAAGTGACATCGTAGAATCGGGGAATTAAACTAATCAGGGTCGACTTTCCTCCCCCACTCATGCCGACAAAGGC</a:t>
            </a:r>
            <a:endParaRPr lang="en-IN" sz="1200" dirty="0"/>
          </a:p>
          <a:p>
            <a:r>
              <a:rPr lang="en-US" sz="1200" dirty="0"/>
              <a:t>GATGGTTTCTCCTTGATTGATGTCCAGGTTGACATTTTTAAGGACGAGCGGATCTTCTTCATCATATCGAAAGGA</a:t>
            </a:r>
            <a:endParaRPr lang="en-IN" sz="1200" dirty="0"/>
          </a:p>
          <a:p>
            <a:r>
              <a:rPr lang="en-US" sz="1200" dirty="0"/>
              <a:t>GACACCCTCTACTTTGACATCGCCTCTCACGTGTTCCATTTTCTTCGCTCCCGGTTTATCGATAATGTCATATTTCT</a:t>
            </a:r>
            <a:endParaRPr lang="en-IN" sz="1200" dirty="0"/>
          </a:p>
          <a:p>
            <a:r>
              <a:rPr lang="en-US" sz="1200" dirty="0"/>
              <a:t>CATCCACAAATTCAAAAACACGATCCATGGAGGCGATGGATTGCGTAAGCACTGTCGCTGAATTGACGAGGCG</a:t>
            </a:r>
            <a:endParaRPr lang="en-IN" sz="1200" dirty="0"/>
          </a:p>
          <a:p>
            <a:r>
              <a:rPr lang="en-US" sz="1200" dirty="0"/>
              <a:t>GCGTAGCGGATTATATACACGATCCATATAGCCGACAAACGCAACCATAGTACCGACGGTCAGGGACCCTGTG</a:t>
            </a:r>
            <a:endParaRPr lang="en-IN" sz="1200" dirty="0"/>
          </a:p>
          <a:p>
            <a:r>
              <a:rPr lang="en-US" sz="1200" dirty="0"/>
              <a:t>ATGACTTGATACCCGGCAAAAGCAATGACTAATAATGGAGCAAGATCTGTAATTGTATTGGTTACAGAATAGGT</a:t>
            </a:r>
            <a:endParaRPr lang="en-IN" sz="1200" dirty="0"/>
          </a:p>
          <a:p>
            <a:r>
              <a:rPr lang="en-US" sz="1200" dirty="0"/>
              <a:t>GTAAGCGTTCCAGTTGGTATGGGTGATCGCTTTATCCAGGAAGTTCTTATTCTTCACATCAAACTGTTCTTGTTCA</a:t>
            </a:r>
            <a:endParaRPr lang="en-IN" sz="1200" dirty="0"/>
          </a:p>
          <a:p>
            <a:r>
              <a:rPr lang="en-US" sz="1200" dirty="0"/>
              <a:t>TGATCCTCTAAAGCGAAACTCCTCGTCACCGGAACCCCCTGTACCCGTTCATGCAAATGCCCCTGTACTTCTGCA</a:t>
            </a:r>
            <a:endParaRPr lang="en-IN" sz="1200" dirty="0"/>
          </a:p>
          <a:p>
            <a:r>
              <a:rPr lang="en-US" sz="1200" dirty="0"/>
              <a:t>AGGGCCTGTGAGCGATCGCGTGTAAGCTTTCGTAACCTCGCGTAAAAATATTTGACCGCAAAGCCGTAAAAAG</a:t>
            </a:r>
            <a:endParaRPr lang="en-IN" sz="1200" dirty="0"/>
          </a:p>
          <a:p>
            <a:r>
              <a:rPr lang="en-US" sz="1200" dirty="0"/>
              <a:t>GGAACAAAGCAATAGACACCAATGTCAGCCAAGGATCCTCTAGAGTCGACGGTACGATCGCGTGTAGCTTTCG</a:t>
            </a:r>
            <a:endParaRPr lang="en-IN" sz="1200" dirty="0"/>
          </a:p>
          <a:p>
            <a:r>
              <a:rPr lang="en-US" sz="1200" dirty="0"/>
              <a:t>TAACCTCGCGTAAAAATATTTGACACGCAAAGCCGTAAAAAGGGAACAAAGCAATAGACACCAATGTCAGCCA</a:t>
            </a:r>
            <a:endParaRPr lang="en-IN" sz="1200" dirty="0"/>
          </a:p>
          <a:p>
            <a:r>
              <a:rPr lang="en-US" sz="1200" dirty="0"/>
              <a:t>AGGATCCTCTAGAGTCGACCTGCAGGCATGCAAGCTTGGCGTAATCATGGTCATAGCTGTTTCCTG 3’</a:t>
            </a:r>
            <a:endParaRPr lang="en-IN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5430808" y="6948264"/>
            <a:ext cx="83708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500" b="1" dirty="0">
                <a:latin typeface="Arial Black" pitchFamily="34" charset="0"/>
              </a:rPr>
              <a:t>Fig S2</a:t>
            </a:r>
            <a:endParaRPr lang="en-IN" sz="1500" dirty="0">
              <a:latin typeface="Arial Black" pitchFamily="34" charset="0"/>
            </a:endParaRPr>
          </a:p>
          <a:p>
            <a:endParaRPr lang="en-IN" sz="1500" dirty="0">
              <a:latin typeface="Arial Black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99392" y="7343144"/>
            <a:ext cx="68580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S2. Nucleotide sequence of </a:t>
            </a:r>
            <a:r>
              <a:rPr lang="en-US" b="1" i="1" dirty="0"/>
              <a:t>H. </a:t>
            </a:r>
            <a:r>
              <a:rPr lang="en-US" b="1" i="1" dirty="0" err="1"/>
              <a:t>trueperi</a:t>
            </a:r>
            <a:r>
              <a:rPr lang="en-US" b="1" dirty="0"/>
              <a:t> SS1 genomic DNA insert in STC clone corresponding to 2301 </a:t>
            </a:r>
            <a:r>
              <a:rPr lang="en-US" b="1" dirty="0" err="1"/>
              <a:t>bp</a:t>
            </a:r>
            <a:r>
              <a:rPr lang="en-US" b="1" dirty="0"/>
              <a:t>. </a:t>
            </a:r>
            <a:r>
              <a:rPr lang="en-US" dirty="0"/>
              <a:t>The insert was sequenced on both strands using pUC19 primers. The two sequences were aligned and overlaps were removed to assemble the sequence of 2301 </a:t>
            </a:r>
            <a:r>
              <a:rPr lang="en-US" dirty="0" err="1"/>
              <a:t>bp</a:t>
            </a:r>
            <a:endParaRPr lang="en-IN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747941" y="169168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263510" y="176368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04995" y="370790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51358" y="3707904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573016" y="558011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085184" y="7993253"/>
            <a:ext cx="8640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Arial Black" pitchFamily="34" charset="0"/>
              </a:rPr>
              <a:t>Fig S3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28485" y="3167845"/>
            <a:ext cx="7073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DH5</a:t>
            </a:r>
            <a:r>
              <a:rPr lang="el-GR" sz="1500" b="1" dirty="0">
                <a:latin typeface="+mj-lt"/>
              </a:rPr>
              <a:t>α</a:t>
            </a:r>
            <a:endParaRPr lang="en-IN" sz="1500" b="1" dirty="0">
              <a:latin typeface="+mj-lt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93190" y="2421553"/>
            <a:ext cx="48605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STC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4773" y="2759751"/>
            <a:ext cx="89960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500" b="1" dirty="0">
                <a:latin typeface="+mj-lt"/>
              </a:rPr>
              <a:t>pGEX4T2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729738" y="3081941"/>
            <a:ext cx="7073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DH5</a:t>
            </a:r>
            <a:r>
              <a:rPr lang="el-GR" sz="1500" b="1" dirty="0">
                <a:latin typeface="+mj-lt"/>
              </a:rPr>
              <a:t>α</a:t>
            </a:r>
            <a:endParaRPr lang="en-IN" sz="1500" b="1" dirty="0">
              <a:latin typeface="+mj-lt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846127" y="2433027"/>
            <a:ext cx="48605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STC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457081" y="2735796"/>
            <a:ext cx="89960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500" b="1" dirty="0">
                <a:latin typeface="+mj-lt"/>
              </a:rPr>
              <a:t>pGEX4T2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92548" y="5040925"/>
            <a:ext cx="7073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DH5</a:t>
            </a:r>
            <a:r>
              <a:rPr lang="el-GR" sz="1500" b="1" dirty="0">
                <a:latin typeface="+mj-lt"/>
              </a:rPr>
              <a:t>α</a:t>
            </a:r>
            <a:endParaRPr lang="en-IN" sz="1500" b="1" dirty="0">
              <a:latin typeface="+mj-lt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36563" y="4410710"/>
            <a:ext cx="48605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STC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8147" y="4700438"/>
            <a:ext cx="89960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pGEX4T2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670790" y="4918144"/>
            <a:ext cx="7073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DH5</a:t>
            </a:r>
            <a:r>
              <a:rPr lang="el-GR" sz="1500" b="1" dirty="0">
                <a:latin typeface="+mj-lt"/>
              </a:rPr>
              <a:t>α</a:t>
            </a:r>
            <a:endParaRPr lang="en-IN" sz="1500" b="1" dirty="0">
              <a:latin typeface="+mj-lt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827467" y="4270073"/>
            <a:ext cx="48605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STC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438420" y="4602054"/>
            <a:ext cx="89960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500" b="1" dirty="0">
                <a:latin typeface="+mj-lt"/>
              </a:rPr>
              <a:t>pGEX4T2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145563" y="6769117"/>
            <a:ext cx="7073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DH5</a:t>
            </a:r>
            <a:r>
              <a:rPr lang="el-GR" sz="1500" b="1" dirty="0">
                <a:latin typeface="+mj-lt"/>
              </a:rPr>
              <a:t>α</a:t>
            </a:r>
            <a:endParaRPr lang="en-IN" sz="1500" b="1" dirty="0">
              <a:latin typeface="+mj-lt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338247" y="6171786"/>
            <a:ext cx="48605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+mj-lt"/>
              </a:rPr>
              <a:t>STC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953119" y="6482749"/>
            <a:ext cx="89960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500" b="1" dirty="0">
                <a:latin typeface="+mj-lt"/>
              </a:rPr>
              <a:t>pGEX4T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03944F0-0B6A-458C-A87F-692C884E1C00}"/>
              </a:ext>
            </a:extLst>
          </p:cNvPr>
          <p:cNvSpPr txBox="1"/>
          <p:nvPr/>
        </p:nvSpPr>
        <p:spPr>
          <a:xfrm>
            <a:off x="4941168" y="8592398"/>
            <a:ext cx="11464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 Black" pitchFamily="34" charset="0"/>
              </a:rPr>
              <a:t>Continued</a:t>
            </a:r>
            <a:endParaRPr lang="en-IN" sz="1350" b="1" dirty="0">
              <a:latin typeface="Arial Black" pitchFamily="34" charset="0"/>
            </a:endParaRPr>
          </a:p>
        </p:txBody>
      </p:sp>
      <p:sp>
        <p:nvSpPr>
          <p:cNvPr id="36" name="Right Triangle 35">
            <a:extLst>
              <a:ext uri="{FF2B5EF4-FFF2-40B4-BE49-F238E27FC236}">
                <a16:creationId xmlns:a16="http://schemas.microsoft.com/office/drawing/2014/main" id="{972D9A1D-2946-451D-A544-5552AD676AD3}"/>
              </a:ext>
            </a:extLst>
          </p:cNvPr>
          <p:cNvSpPr/>
          <p:nvPr/>
        </p:nvSpPr>
        <p:spPr>
          <a:xfrm>
            <a:off x="1095433" y="2048211"/>
            <a:ext cx="1922784" cy="177004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pic>
        <p:nvPicPr>
          <p:cNvPr id="41" name="Picture 5" descr="F:\DCIM\100CANON\IMG_1672.JPG"/>
          <p:cNvPicPr>
            <a:picLocks noChangeAspect="1" noChangeArrowheads="1"/>
          </p:cNvPicPr>
          <p:nvPr/>
        </p:nvPicPr>
        <p:blipFill>
          <a:blip r:embed="rId2" cstate="print">
            <a:lum bright="-10000" contrast="40000"/>
          </a:blip>
          <a:srcRect l="20907" t="38007" r="29853" b="25027"/>
          <a:stretch>
            <a:fillRect/>
          </a:stretch>
        </p:blipFill>
        <p:spPr bwMode="auto">
          <a:xfrm flipH="1">
            <a:off x="4365104" y="2267746"/>
            <a:ext cx="2348880" cy="1312023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2" name="Picture 8" descr="F:\DCIM\100CANON\IMG_1637.JPG"/>
          <p:cNvPicPr>
            <a:picLocks noChangeAspect="1" noChangeArrowheads="1"/>
          </p:cNvPicPr>
          <p:nvPr/>
        </p:nvPicPr>
        <p:blipFill>
          <a:blip r:embed="rId3" cstate="print">
            <a:lum bright="-10000" contrast="40000"/>
          </a:blip>
          <a:srcRect l="23343" t="42143" r="32294" b="27215"/>
          <a:stretch>
            <a:fillRect/>
          </a:stretch>
        </p:blipFill>
        <p:spPr bwMode="auto">
          <a:xfrm flipH="1">
            <a:off x="980728" y="2267745"/>
            <a:ext cx="2232248" cy="1298116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3" name="Picture 3" descr="F:\DCIM\100CANON\IMG_1676.JPG"/>
          <p:cNvPicPr>
            <a:picLocks noChangeAspect="1" noChangeArrowheads="1"/>
          </p:cNvPicPr>
          <p:nvPr/>
        </p:nvPicPr>
        <p:blipFill>
          <a:blip r:embed="rId4" cstate="print">
            <a:lum bright="-10000" contrast="40000"/>
          </a:blip>
          <a:srcRect l="24650" t="39889" r="24941" b="20231"/>
          <a:stretch>
            <a:fillRect/>
          </a:stretch>
        </p:blipFill>
        <p:spPr bwMode="auto">
          <a:xfrm flipH="1">
            <a:off x="908719" y="4067945"/>
            <a:ext cx="2232249" cy="1327387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4" name="Picture 2" descr="F:\DCIM\100CANON\IMG_1685.JPG"/>
          <p:cNvPicPr>
            <a:picLocks noChangeAspect="1" noChangeArrowheads="1"/>
          </p:cNvPicPr>
          <p:nvPr/>
        </p:nvPicPr>
        <p:blipFill>
          <a:blip r:embed="rId5" cstate="print">
            <a:lum bright="-10000" contrast="40000"/>
          </a:blip>
          <a:srcRect l="18500" t="40328" r="28265" b="26549"/>
          <a:stretch>
            <a:fillRect/>
          </a:stretch>
        </p:blipFill>
        <p:spPr bwMode="auto">
          <a:xfrm flipH="1">
            <a:off x="4293096" y="4139952"/>
            <a:ext cx="2390898" cy="1296144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5" name="Picture 2" descr="F:\DCIM\100CANON\IMG_1683.JPG"/>
          <p:cNvPicPr>
            <a:picLocks noChangeAspect="1" noChangeArrowheads="1"/>
          </p:cNvPicPr>
          <p:nvPr/>
        </p:nvPicPr>
        <p:blipFill>
          <a:blip r:embed="rId6" cstate="print">
            <a:lum bright="-10000" contrast="40000"/>
          </a:blip>
          <a:srcRect l="10626" t="33099" r="37392" b="21302"/>
          <a:stretch>
            <a:fillRect/>
          </a:stretch>
        </p:blipFill>
        <p:spPr bwMode="auto">
          <a:xfrm flipH="1">
            <a:off x="2852937" y="5966767"/>
            <a:ext cx="2232248" cy="1299615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</p:cSld>
  <p:clrMapOvr>
    <a:masterClrMapping/>
  </p:clrMapOvr>
  <p:transition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/>
          <p:cNvGrpSpPr/>
          <p:nvPr/>
        </p:nvGrpSpPr>
        <p:grpSpPr>
          <a:xfrm>
            <a:off x="-63106" y="107504"/>
            <a:ext cx="6811705" cy="6299829"/>
            <a:chOff x="-63106" y="1979712"/>
            <a:chExt cx="6811705" cy="6299829"/>
          </a:xfrm>
        </p:grpSpPr>
        <p:pic>
          <p:nvPicPr>
            <p:cNvPr id="7" name="Picture 9" descr="F:\DCIM\100CANON\IMG_1633.JPG"/>
            <p:cNvPicPr>
              <a:picLocks noChangeAspect="1" noChangeArrowheads="1"/>
            </p:cNvPicPr>
            <p:nvPr/>
          </p:nvPicPr>
          <p:blipFill>
            <a:blip r:embed="rId2" cstate="print">
              <a:lum bright="-10000" contrast="40000"/>
            </a:blip>
            <a:srcRect l="29396" t="38073" r="33900" b="35535"/>
            <a:stretch>
              <a:fillRect/>
            </a:stretch>
          </p:blipFill>
          <p:spPr bwMode="auto">
            <a:xfrm>
              <a:off x="872717" y="2422224"/>
              <a:ext cx="2342317" cy="1357688"/>
            </a:xfrm>
            <a:prstGeom prst="rect">
              <a:avLst/>
            </a:prstGeom>
            <a:ln w="38100" cap="sq">
              <a:noFill/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4" name="TextBox 13"/>
            <p:cNvSpPr txBox="1"/>
            <p:nvPr/>
          </p:nvSpPr>
          <p:spPr>
            <a:xfrm>
              <a:off x="1799238" y="2020228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836958" y="3886907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252559" y="1979712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373216" y="3863823"/>
              <a:ext cx="2487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540254" y="5805025"/>
              <a:ext cx="2487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1347" y="3394333"/>
              <a:ext cx="7073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DH5</a:t>
              </a:r>
              <a:r>
                <a:rPr lang="el-GR" sz="1500" b="1" dirty="0">
                  <a:latin typeface="+mj-lt"/>
                </a:rPr>
                <a:t>α</a:t>
              </a:r>
              <a:endParaRPr lang="en-IN" sz="1500" b="1" dirty="0">
                <a:latin typeface="+mj-lt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04664" y="2608197"/>
              <a:ext cx="48605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STC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9116" y="3024701"/>
              <a:ext cx="899605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pGEX4T2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29341" y="5214121"/>
              <a:ext cx="7073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DH5</a:t>
              </a:r>
              <a:r>
                <a:rPr lang="el-GR" sz="1500" b="1" dirty="0">
                  <a:latin typeface="+mj-lt"/>
                </a:rPr>
                <a:t>α</a:t>
              </a:r>
              <a:endParaRPr lang="en-IN" sz="1500" b="1" dirty="0">
                <a:latin typeface="+mj-lt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50658" y="4470811"/>
              <a:ext cx="48605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STC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-63106" y="4860033"/>
              <a:ext cx="899605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pGEX4T2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657731" y="3384741"/>
              <a:ext cx="7073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DH5</a:t>
              </a:r>
              <a:r>
                <a:rPr lang="el-GR" sz="1500" b="1" dirty="0">
                  <a:latin typeface="+mj-lt"/>
                </a:rPr>
                <a:t>α</a:t>
              </a:r>
              <a:endParaRPr lang="en-IN" sz="1500" b="1" dirty="0">
                <a:latin typeface="+mj-lt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833068" y="2584245"/>
              <a:ext cx="48605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STC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465285" y="2987825"/>
              <a:ext cx="899605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pGEX4T2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693738" y="5214121"/>
              <a:ext cx="7073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DH5</a:t>
              </a:r>
              <a:r>
                <a:rPr lang="el-GR" sz="1500" b="1" dirty="0">
                  <a:latin typeface="+mj-lt"/>
                </a:rPr>
                <a:t>α</a:t>
              </a:r>
              <a:endParaRPr lang="en-IN" sz="1500" b="1" dirty="0">
                <a:latin typeface="+mj-lt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869075" y="4427985"/>
              <a:ext cx="48605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STC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501292" y="4829981"/>
              <a:ext cx="899605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pGEX4T2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713515" y="7129157"/>
              <a:ext cx="7073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DH5</a:t>
              </a:r>
              <a:r>
                <a:rPr lang="el-GR" sz="1500" b="1" dirty="0">
                  <a:latin typeface="+mj-lt"/>
                </a:rPr>
                <a:t>α</a:t>
              </a:r>
              <a:endParaRPr lang="en-IN" sz="1500" b="1" dirty="0">
                <a:latin typeface="+mj-lt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903591" y="6339134"/>
              <a:ext cx="48605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STC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535808" y="6717177"/>
              <a:ext cx="899605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500" b="1" dirty="0">
                  <a:latin typeface="+mj-lt"/>
                </a:rPr>
                <a:t>pGEX4T2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661248" y="7956376"/>
              <a:ext cx="864096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500" b="1" dirty="0">
                  <a:latin typeface="Arial Black" pitchFamily="34" charset="0"/>
                </a:rPr>
                <a:t>Fig S3</a:t>
              </a:r>
            </a:p>
          </p:txBody>
        </p:sp>
        <p:pic>
          <p:nvPicPr>
            <p:cNvPr id="32" name="Picture 4" descr="F:\DCIM\100CANON\IMG_1652.JPG"/>
            <p:cNvPicPr>
              <a:picLocks noChangeAspect="1" noChangeArrowheads="1"/>
            </p:cNvPicPr>
            <p:nvPr/>
          </p:nvPicPr>
          <p:blipFill>
            <a:blip r:embed="rId3" cstate="print">
              <a:lum bright="-10000" contrast="40000"/>
            </a:blip>
            <a:srcRect l="33437" t="36595" r="34458" b="39730"/>
            <a:stretch>
              <a:fillRect/>
            </a:stretch>
          </p:blipFill>
          <p:spPr bwMode="auto">
            <a:xfrm flipH="1">
              <a:off x="4397799" y="2411763"/>
              <a:ext cx="2350800" cy="1361895"/>
            </a:xfrm>
            <a:prstGeom prst="rect">
              <a:avLst/>
            </a:prstGeom>
            <a:ln w="38100" cap="sq">
              <a:noFill/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pic>
          <p:nvPicPr>
            <p:cNvPr id="34" name="Picture 7" descr="F:\DCIM\100CANON\IMG_1680.JPG"/>
            <p:cNvPicPr>
              <a:picLocks noChangeAspect="1" noChangeArrowheads="1"/>
            </p:cNvPicPr>
            <p:nvPr/>
          </p:nvPicPr>
          <p:blipFill>
            <a:blip r:embed="rId4" cstate="print">
              <a:lum bright="-10000" contrast="40000"/>
            </a:blip>
            <a:srcRect l="20268" t="40269" r="30019" b="30413"/>
            <a:stretch>
              <a:fillRect/>
            </a:stretch>
          </p:blipFill>
          <p:spPr bwMode="auto">
            <a:xfrm flipH="1">
              <a:off x="836712" y="4283970"/>
              <a:ext cx="2376264" cy="1296143"/>
            </a:xfrm>
            <a:prstGeom prst="rect">
              <a:avLst/>
            </a:prstGeom>
            <a:ln w="38100" cap="sq">
              <a:noFill/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pic>
          <p:nvPicPr>
            <p:cNvPr id="35" name="Picture 6" descr="F:\DCIM\100CANON\IMG_1674.JPG"/>
            <p:cNvPicPr>
              <a:picLocks noChangeAspect="1" noChangeArrowheads="1"/>
            </p:cNvPicPr>
            <p:nvPr/>
          </p:nvPicPr>
          <p:blipFill>
            <a:blip r:embed="rId5" cstate="print">
              <a:lum bright="-10000" contrast="40000"/>
            </a:blip>
            <a:srcRect l="26892" t="46257" r="30628" b="31446"/>
            <a:stretch>
              <a:fillRect/>
            </a:stretch>
          </p:blipFill>
          <p:spPr bwMode="auto">
            <a:xfrm flipH="1">
              <a:off x="4362912" y="4283967"/>
              <a:ext cx="2350800" cy="1321068"/>
            </a:xfrm>
            <a:prstGeom prst="rect">
              <a:avLst/>
            </a:prstGeom>
            <a:ln w="38100" cap="sq">
              <a:noFill/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pic>
          <p:nvPicPr>
            <p:cNvPr id="36" name="Picture 3" descr="F:\DCIM\100CANON\IMG_1684.JPG"/>
            <p:cNvPicPr>
              <a:picLocks noChangeAspect="1" noChangeArrowheads="1"/>
            </p:cNvPicPr>
            <p:nvPr/>
          </p:nvPicPr>
          <p:blipFill>
            <a:blip r:embed="rId6" cstate="print">
              <a:lum bright="-10000" contrast="40000"/>
            </a:blip>
            <a:srcRect l="16667" t="50291" r="34654" b="21725"/>
            <a:stretch>
              <a:fillRect/>
            </a:stretch>
          </p:blipFill>
          <p:spPr bwMode="auto">
            <a:xfrm flipH="1">
              <a:off x="2420887" y="6248280"/>
              <a:ext cx="2385657" cy="1348056"/>
            </a:xfrm>
            <a:prstGeom prst="rect">
              <a:avLst/>
            </a:prstGeom>
            <a:ln w="38100" cap="sq">
              <a:noFill/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</p:grpSp>
      <p:sp>
        <p:nvSpPr>
          <p:cNvPr id="38" name="Rectangle 37"/>
          <p:cNvSpPr/>
          <p:nvPr/>
        </p:nvSpPr>
        <p:spPr>
          <a:xfrm>
            <a:off x="144016" y="6804248"/>
            <a:ext cx="6597352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upplementary Figure S3.</a:t>
            </a:r>
            <a:r>
              <a:rPr lang="en-US" dirty="0"/>
              <a:t> </a:t>
            </a:r>
            <a:r>
              <a:rPr lang="en-US" b="1" dirty="0"/>
              <a:t>Growth characteristics of STC </a:t>
            </a:r>
            <a:r>
              <a:rPr lang="en-US" b="1" dirty="0" err="1"/>
              <a:t>subcloned</a:t>
            </a:r>
            <a:r>
              <a:rPr lang="en-US" b="1" dirty="0"/>
              <a:t> in pGEX4T2.</a:t>
            </a:r>
            <a:r>
              <a:rPr lang="en-US" dirty="0"/>
              <a:t> The growth of recombinant clone</a:t>
            </a:r>
            <a:r>
              <a:rPr lang="en-US" b="1" i="1" dirty="0"/>
              <a:t> </a:t>
            </a:r>
            <a:r>
              <a:rPr lang="en-US" dirty="0"/>
              <a:t>STC, control DH5α transformed with pGEX4T2 and DH5α host strain were analyzed for </a:t>
            </a:r>
            <a:r>
              <a:rPr lang="en-US" dirty="0" err="1"/>
              <a:t>NaCl</a:t>
            </a:r>
            <a:r>
              <a:rPr lang="en-US" dirty="0"/>
              <a:t> tolerance in LB agar medium. A ten fold serial dilution (from left to right as indicated above panel </a:t>
            </a:r>
            <a:r>
              <a:rPr lang="en-US" b="1" dirty="0"/>
              <a:t>a</a:t>
            </a:r>
            <a:r>
              <a:rPr lang="en-US" dirty="0"/>
              <a:t>) of each strain was spotted on LB medium (</a:t>
            </a:r>
            <a:r>
              <a:rPr lang="en-US" b="1" dirty="0"/>
              <a:t>a </a:t>
            </a:r>
            <a:r>
              <a:rPr lang="en-US" dirty="0"/>
              <a:t>- </a:t>
            </a:r>
            <a:r>
              <a:rPr lang="en-US" b="1" dirty="0"/>
              <a:t>e</a:t>
            </a:r>
            <a:r>
              <a:rPr lang="en-US" dirty="0"/>
              <a:t>) and LB medium containing </a:t>
            </a:r>
            <a:r>
              <a:rPr lang="en-US" dirty="0" err="1"/>
              <a:t>ampicillin</a:t>
            </a:r>
            <a:r>
              <a:rPr lang="en-US" dirty="0"/>
              <a:t> (</a:t>
            </a:r>
            <a:r>
              <a:rPr lang="en-US" b="1" dirty="0"/>
              <a:t>f – j</a:t>
            </a:r>
            <a:r>
              <a:rPr lang="en-US" dirty="0"/>
              <a:t>) and increasing concentration of </a:t>
            </a:r>
            <a:r>
              <a:rPr lang="en-US" dirty="0" err="1"/>
              <a:t>NaCl</a:t>
            </a:r>
            <a:r>
              <a:rPr lang="en-US" dirty="0"/>
              <a:t> as follows: 0 (</a:t>
            </a:r>
            <a:r>
              <a:rPr lang="en-US" b="1" dirty="0"/>
              <a:t>a</a:t>
            </a:r>
            <a:r>
              <a:rPr lang="en-US" dirty="0"/>
              <a:t> and </a:t>
            </a:r>
            <a:r>
              <a:rPr lang="en-US" b="1" dirty="0"/>
              <a:t>f</a:t>
            </a:r>
            <a:r>
              <a:rPr lang="en-US" dirty="0"/>
              <a:t>), 0.5 (</a:t>
            </a:r>
            <a:r>
              <a:rPr lang="en-US" b="1" dirty="0"/>
              <a:t>b</a:t>
            </a:r>
            <a:r>
              <a:rPr lang="en-US" dirty="0"/>
              <a:t> and </a:t>
            </a:r>
            <a:r>
              <a:rPr lang="en-US" b="1" dirty="0"/>
              <a:t>g</a:t>
            </a:r>
            <a:r>
              <a:rPr lang="en-US" dirty="0"/>
              <a:t>), 0.75 (</a:t>
            </a:r>
            <a:r>
              <a:rPr lang="en-US" b="1" dirty="0"/>
              <a:t>c</a:t>
            </a:r>
            <a:r>
              <a:rPr lang="en-US" dirty="0"/>
              <a:t> and </a:t>
            </a:r>
            <a:r>
              <a:rPr lang="en-US" b="1" dirty="0"/>
              <a:t>h</a:t>
            </a:r>
            <a:r>
              <a:rPr lang="en-US" dirty="0"/>
              <a:t>), 1.0 (</a:t>
            </a:r>
            <a:r>
              <a:rPr lang="en-US" b="1" dirty="0"/>
              <a:t>d</a:t>
            </a:r>
            <a:r>
              <a:rPr lang="en-US" dirty="0"/>
              <a:t> and </a:t>
            </a:r>
            <a:r>
              <a:rPr lang="en-US" b="1" dirty="0" err="1"/>
              <a:t>i</a:t>
            </a:r>
            <a:r>
              <a:rPr lang="en-US" dirty="0"/>
              <a:t>) and 1.5 M (</a:t>
            </a:r>
            <a:r>
              <a:rPr lang="en-US" b="1" dirty="0"/>
              <a:t>e</a:t>
            </a:r>
            <a:r>
              <a:rPr lang="en-US" dirty="0"/>
              <a:t> and </a:t>
            </a:r>
            <a:r>
              <a:rPr lang="en-US" b="1" dirty="0"/>
              <a:t>j</a:t>
            </a:r>
            <a:r>
              <a:rPr lang="en-US" dirty="0"/>
              <a:t>). </a:t>
            </a:r>
            <a:endParaRPr lang="en-IN" dirty="0"/>
          </a:p>
        </p:txBody>
      </p:sp>
    </p:spTree>
  </p:cSld>
  <p:clrMapOvr>
    <a:masterClrMapping/>
  </p:clrMapOvr>
  <p:transition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393</Words>
  <Application>Microsoft Office PowerPoint</Application>
  <PresentationFormat>On-screen Show (4:3)</PresentationFormat>
  <Paragraphs>8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Arial Black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upta</dc:creator>
  <cp:lastModifiedBy>KAMAL DEV</cp:lastModifiedBy>
  <cp:revision>5</cp:revision>
  <dcterms:created xsi:type="dcterms:W3CDTF">2020-08-27T09:01:59Z</dcterms:created>
  <dcterms:modified xsi:type="dcterms:W3CDTF">2020-08-28T16:29:39Z</dcterms:modified>
</cp:coreProperties>
</file>